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3" r:id="rId2"/>
  </p:sldIdLst>
  <p:sldSz cx="6858000" cy="9906000" type="A4"/>
  <p:notesSz cx="6783388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DECEC"/>
    <a:srgbClr val="D05AD0"/>
    <a:srgbClr val="01DA02"/>
    <a:srgbClr val="BC14B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947" autoAdjust="0"/>
    <p:restoredTop sz="96433" autoAdjust="0"/>
  </p:normalViewPr>
  <p:slideViewPr>
    <p:cSldViewPr snapToGrid="0">
      <p:cViewPr varScale="1">
        <p:scale>
          <a:sx n="126" d="100"/>
          <a:sy n="126" d="100"/>
        </p:scale>
        <p:origin x="2808" y="208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39468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2350" y="0"/>
            <a:ext cx="2939468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9ACCED-A51B-483E-80EA-C58192E70185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3613" y="1241425"/>
            <a:ext cx="2316162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8339" y="4777194"/>
            <a:ext cx="542671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39468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2350" y="9428584"/>
            <a:ext cx="2939468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18F4EB-17FA-4F5B-82DA-9E6943BA9330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85461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6045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879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86038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04474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36811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15363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54189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84066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3086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56368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36539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298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395" y="3695689"/>
            <a:ext cx="1005840" cy="1005840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4892" y="3695917"/>
            <a:ext cx="1005840" cy="1005840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8076" y="3698421"/>
            <a:ext cx="1005840" cy="100584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8635" y="3698421"/>
            <a:ext cx="1005840" cy="100584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2629" y="1031915"/>
            <a:ext cx="4386253" cy="243337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 rot="16200000">
            <a:off x="-67138" y="4100041"/>
            <a:ext cx="1378845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rimary tumor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56407" y="3654508"/>
            <a:ext cx="6318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PN</a:t>
            </a:r>
            <a:endParaRPr lang="en-GB" sz="10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857213" y="3662548"/>
            <a:ext cx="6340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b="1" dirty="0">
                <a:solidFill>
                  <a:srgbClr val="01DA0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MA</a:t>
            </a:r>
            <a:endParaRPr lang="en-GB" sz="1000" b="1" dirty="0">
              <a:solidFill>
                <a:srgbClr val="01DA0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050034" y="3656159"/>
            <a:ext cx="588918" cy="199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n-GB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953934" y="3666549"/>
            <a:ext cx="8163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dTomato</a:t>
            </a:r>
            <a:endParaRPr lang="en-GB" sz="1000" b="1" dirty="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Freeform 14"/>
          <p:cNvSpPr/>
          <p:nvPr/>
        </p:nvSpPr>
        <p:spPr>
          <a:xfrm>
            <a:off x="4046906" y="3727831"/>
            <a:ext cx="1039624" cy="945038"/>
          </a:xfrm>
          <a:custGeom>
            <a:avLst/>
            <a:gdLst>
              <a:gd name="connsiteX0" fmla="*/ 0 w 1447800"/>
              <a:gd name="connsiteY0" fmla="*/ 1341393 h 1341393"/>
              <a:gd name="connsiteX1" fmla="*/ 60960 w 1447800"/>
              <a:gd name="connsiteY1" fmla="*/ 1295673 h 1341393"/>
              <a:gd name="connsiteX2" fmla="*/ 106680 w 1447800"/>
              <a:gd name="connsiteY2" fmla="*/ 1265193 h 1341393"/>
              <a:gd name="connsiteX3" fmla="*/ 121920 w 1447800"/>
              <a:gd name="connsiteY3" fmla="*/ 1242333 h 1341393"/>
              <a:gd name="connsiteX4" fmla="*/ 129540 w 1447800"/>
              <a:gd name="connsiteY4" fmla="*/ 1219473 h 1341393"/>
              <a:gd name="connsiteX5" fmla="*/ 152400 w 1447800"/>
              <a:gd name="connsiteY5" fmla="*/ 1204233 h 1341393"/>
              <a:gd name="connsiteX6" fmla="*/ 160020 w 1447800"/>
              <a:gd name="connsiteY6" fmla="*/ 1181373 h 1341393"/>
              <a:gd name="connsiteX7" fmla="*/ 198120 w 1447800"/>
              <a:gd name="connsiteY7" fmla="*/ 1128033 h 1341393"/>
              <a:gd name="connsiteX8" fmla="*/ 251460 w 1447800"/>
              <a:gd name="connsiteY8" fmla="*/ 1059453 h 1341393"/>
              <a:gd name="connsiteX9" fmla="*/ 289560 w 1447800"/>
              <a:gd name="connsiteY9" fmla="*/ 990873 h 1341393"/>
              <a:gd name="connsiteX10" fmla="*/ 304800 w 1447800"/>
              <a:gd name="connsiteY10" fmla="*/ 968013 h 1341393"/>
              <a:gd name="connsiteX11" fmla="*/ 335280 w 1447800"/>
              <a:gd name="connsiteY11" fmla="*/ 922293 h 1341393"/>
              <a:gd name="connsiteX12" fmla="*/ 365760 w 1447800"/>
              <a:gd name="connsiteY12" fmla="*/ 884193 h 1341393"/>
              <a:gd name="connsiteX13" fmla="*/ 381000 w 1447800"/>
              <a:gd name="connsiteY13" fmla="*/ 861333 h 1341393"/>
              <a:gd name="connsiteX14" fmla="*/ 403860 w 1447800"/>
              <a:gd name="connsiteY14" fmla="*/ 853713 h 1341393"/>
              <a:gd name="connsiteX15" fmla="*/ 457200 w 1447800"/>
              <a:gd name="connsiteY15" fmla="*/ 815613 h 1341393"/>
              <a:gd name="connsiteX16" fmla="*/ 502920 w 1447800"/>
              <a:gd name="connsiteY16" fmla="*/ 792753 h 1341393"/>
              <a:gd name="connsiteX17" fmla="*/ 525780 w 1447800"/>
              <a:gd name="connsiteY17" fmla="*/ 769893 h 1341393"/>
              <a:gd name="connsiteX18" fmla="*/ 571500 w 1447800"/>
              <a:gd name="connsiteY18" fmla="*/ 739413 h 1341393"/>
              <a:gd name="connsiteX19" fmla="*/ 617220 w 1447800"/>
              <a:gd name="connsiteY19" fmla="*/ 708933 h 1341393"/>
              <a:gd name="connsiteX20" fmla="*/ 640080 w 1447800"/>
              <a:gd name="connsiteY20" fmla="*/ 686073 h 1341393"/>
              <a:gd name="connsiteX21" fmla="*/ 708660 w 1447800"/>
              <a:gd name="connsiteY21" fmla="*/ 632733 h 1341393"/>
              <a:gd name="connsiteX22" fmla="*/ 784860 w 1447800"/>
              <a:gd name="connsiteY22" fmla="*/ 541293 h 1341393"/>
              <a:gd name="connsiteX23" fmla="*/ 807720 w 1447800"/>
              <a:gd name="connsiteY23" fmla="*/ 533673 h 1341393"/>
              <a:gd name="connsiteX24" fmla="*/ 853440 w 1447800"/>
              <a:gd name="connsiteY24" fmla="*/ 495573 h 1341393"/>
              <a:gd name="connsiteX25" fmla="*/ 876300 w 1447800"/>
              <a:gd name="connsiteY25" fmla="*/ 487953 h 1341393"/>
              <a:gd name="connsiteX26" fmla="*/ 944880 w 1447800"/>
              <a:gd name="connsiteY26" fmla="*/ 434613 h 1341393"/>
              <a:gd name="connsiteX27" fmla="*/ 967740 w 1447800"/>
              <a:gd name="connsiteY27" fmla="*/ 419373 h 1341393"/>
              <a:gd name="connsiteX28" fmla="*/ 990600 w 1447800"/>
              <a:gd name="connsiteY28" fmla="*/ 404133 h 1341393"/>
              <a:gd name="connsiteX29" fmla="*/ 1028700 w 1447800"/>
              <a:gd name="connsiteY29" fmla="*/ 373653 h 1341393"/>
              <a:gd name="connsiteX30" fmla="*/ 1051560 w 1447800"/>
              <a:gd name="connsiteY30" fmla="*/ 350793 h 1341393"/>
              <a:gd name="connsiteX31" fmla="*/ 1097280 w 1447800"/>
              <a:gd name="connsiteY31" fmla="*/ 312693 h 1341393"/>
              <a:gd name="connsiteX32" fmla="*/ 1127760 w 1447800"/>
              <a:gd name="connsiteY32" fmla="*/ 251733 h 1341393"/>
              <a:gd name="connsiteX33" fmla="*/ 1135380 w 1447800"/>
              <a:gd name="connsiteY33" fmla="*/ 228873 h 1341393"/>
              <a:gd name="connsiteX34" fmla="*/ 1188720 w 1447800"/>
              <a:gd name="connsiteY34" fmla="*/ 160293 h 1341393"/>
              <a:gd name="connsiteX35" fmla="*/ 1196340 w 1447800"/>
              <a:gd name="connsiteY35" fmla="*/ 137433 h 1341393"/>
              <a:gd name="connsiteX36" fmla="*/ 1219200 w 1447800"/>
              <a:gd name="connsiteY36" fmla="*/ 129813 h 1341393"/>
              <a:gd name="connsiteX37" fmla="*/ 1264920 w 1447800"/>
              <a:gd name="connsiteY37" fmla="*/ 99333 h 1341393"/>
              <a:gd name="connsiteX38" fmla="*/ 1287780 w 1447800"/>
              <a:gd name="connsiteY38" fmla="*/ 84093 h 1341393"/>
              <a:gd name="connsiteX39" fmla="*/ 1325880 w 1447800"/>
              <a:gd name="connsiteY39" fmla="*/ 45993 h 1341393"/>
              <a:gd name="connsiteX40" fmla="*/ 1371600 w 1447800"/>
              <a:gd name="connsiteY40" fmla="*/ 30753 h 1341393"/>
              <a:gd name="connsiteX41" fmla="*/ 1394460 w 1447800"/>
              <a:gd name="connsiteY41" fmla="*/ 23133 h 1341393"/>
              <a:gd name="connsiteX42" fmla="*/ 1440180 w 1447800"/>
              <a:gd name="connsiteY42" fmla="*/ 273 h 1341393"/>
              <a:gd name="connsiteX43" fmla="*/ 1447800 w 1447800"/>
              <a:gd name="connsiteY43" fmla="*/ 273 h 13413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</a:cxnLst>
            <a:rect l="l" t="t" r="r" b="b"/>
            <a:pathLst>
              <a:path w="1447800" h="1341393">
                <a:moveTo>
                  <a:pt x="0" y="1341393"/>
                </a:moveTo>
                <a:cubicBezTo>
                  <a:pt x="88388" y="1253005"/>
                  <a:pt x="1112" y="1328922"/>
                  <a:pt x="60960" y="1295673"/>
                </a:cubicBezTo>
                <a:cubicBezTo>
                  <a:pt x="76971" y="1286778"/>
                  <a:pt x="106680" y="1265193"/>
                  <a:pt x="106680" y="1265193"/>
                </a:cubicBezTo>
                <a:cubicBezTo>
                  <a:pt x="111760" y="1257573"/>
                  <a:pt x="117824" y="1250524"/>
                  <a:pt x="121920" y="1242333"/>
                </a:cubicBezTo>
                <a:cubicBezTo>
                  <a:pt x="125512" y="1235149"/>
                  <a:pt x="124522" y="1225745"/>
                  <a:pt x="129540" y="1219473"/>
                </a:cubicBezTo>
                <a:cubicBezTo>
                  <a:pt x="135261" y="1212322"/>
                  <a:pt x="144780" y="1209313"/>
                  <a:pt x="152400" y="1204233"/>
                </a:cubicBezTo>
                <a:cubicBezTo>
                  <a:pt x="154940" y="1196613"/>
                  <a:pt x="156428" y="1188557"/>
                  <a:pt x="160020" y="1181373"/>
                </a:cubicBezTo>
                <a:cubicBezTo>
                  <a:pt x="164844" y="1171724"/>
                  <a:pt x="193978" y="1132865"/>
                  <a:pt x="198120" y="1128033"/>
                </a:cubicBezTo>
                <a:cubicBezTo>
                  <a:pt x="219637" y="1102930"/>
                  <a:pt x="239298" y="1095939"/>
                  <a:pt x="251460" y="1059453"/>
                </a:cubicBezTo>
                <a:cubicBezTo>
                  <a:pt x="264872" y="1019217"/>
                  <a:pt x="254625" y="1043276"/>
                  <a:pt x="289560" y="990873"/>
                </a:cubicBezTo>
                <a:cubicBezTo>
                  <a:pt x="294640" y="983253"/>
                  <a:pt x="301904" y="976701"/>
                  <a:pt x="304800" y="968013"/>
                </a:cubicBezTo>
                <a:cubicBezTo>
                  <a:pt x="315828" y="934930"/>
                  <a:pt x="306740" y="950833"/>
                  <a:pt x="335280" y="922293"/>
                </a:cubicBezTo>
                <a:cubicBezTo>
                  <a:pt x="350115" y="877789"/>
                  <a:pt x="331293" y="918660"/>
                  <a:pt x="365760" y="884193"/>
                </a:cubicBezTo>
                <a:cubicBezTo>
                  <a:pt x="372236" y="877717"/>
                  <a:pt x="373849" y="867054"/>
                  <a:pt x="381000" y="861333"/>
                </a:cubicBezTo>
                <a:cubicBezTo>
                  <a:pt x="387272" y="856315"/>
                  <a:pt x="396676" y="857305"/>
                  <a:pt x="403860" y="853713"/>
                </a:cubicBezTo>
                <a:cubicBezTo>
                  <a:pt x="427447" y="841919"/>
                  <a:pt x="433039" y="829419"/>
                  <a:pt x="457200" y="815613"/>
                </a:cubicBezTo>
                <a:cubicBezTo>
                  <a:pt x="500939" y="790619"/>
                  <a:pt x="459477" y="828956"/>
                  <a:pt x="502920" y="792753"/>
                </a:cubicBezTo>
                <a:cubicBezTo>
                  <a:pt x="511199" y="785854"/>
                  <a:pt x="517274" y="776509"/>
                  <a:pt x="525780" y="769893"/>
                </a:cubicBezTo>
                <a:cubicBezTo>
                  <a:pt x="540238" y="758648"/>
                  <a:pt x="558548" y="752365"/>
                  <a:pt x="571500" y="739413"/>
                </a:cubicBezTo>
                <a:cubicBezTo>
                  <a:pt x="600040" y="710873"/>
                  <a:pt x="584137" y="719961"/>
                  <a:pt x="617220" y="708933"/>
                </a:cubicBezTo>
                <a:cubicBezTo>
                  <a:pt x="624840" y="701313"/>
                  <a:pt x="631574" y="692689"/>
                  <a:pt x="640080" y="686073"/>
                </a:cubicBezTo>
                <a:cubicBezTo>
                  <a:pt x="672491" y="660865"/>
                  <a:pt x="685954" y="661926"/>
                  <a:pt x="708660" y="632733"/>
                </a:cubicBezTo>
                <a:cubicBezTo>
                  <a:pt x="725740" y="610773"/>
                  <a:pt x="756024" y="550905"/>
                  <a:pt x="784860" y="541293"/>
                </a:cubicBezTo>
                <a:lnTo>
                  <a:pt x="807720" y="533673"/>
                </a:lnTo>
                <a:cubicBezTo>
                  <a:pt x="824572" y="516821"/>
                  <a:pt x="832222" y="506182"/>
                  <a:pt x="853440" y="495573"/>
                </a:cubicBezTo>
                <a:cubicBezTo>
                  <a:pt x="860624" y="491981"/>
                  <a:pt x="868680" y="490493"/>
                  <a:pt x="876300" y="487953"/>
                </a:cubicBezTo>
                <a:cubicBezTo>
                  <a:pt x="912112" y="452141"/>
                  <a:pt x="890194" y="471071"/>
                  <a:pt x="944880" y="434613"/>
                </a:cubicBezTo>
                <a:lnTo>
                  <a:pt x="967740" y="419373"/>
                </a:lnTo>
                <a:lnTo>
                  <a:pt x="990600" y="404133"/>
                </a:lnTo>
                <a:cubicBezTo>
                  <a:pt x="1024684" y="353008"/>
                  <a:pt x="984533" y="403098"/>
                  <a:pt x="1028700" y="373653"/>
                </a:cubicBezTo>
                <a:cubicBezTo>
                  <a:pt x="1037666" y="367675"/>
                  <a:pt x="1043281" y="357692"/>
                  <a:pt x="1051560" y="350793"/>
                </a:cubicBezTo>
                <a:cubicBezTo>
                  <a:pt x="1115213" y="297749"/>
                  <a:pt x="1030494" y="379479"/>
                  <a:pt x="1097280" y="312693"/>
                </a:cubicBezTo>
                <a:cubicBezTo>
                  <a:pt x="1114463" y="261144"/>
                  <a:pt x="1091770" y="323713"/>
                  <a:pt x="1127760" y="251733"/>
                </a:cubicBezTo>
                <a:cubicBezTo>
                  <a:pt x="1131352" y="244549"/>
                  <a:pt x="1131479" y="235894"/>
                  <a:pt x="1135380" y="228873"/>
                </a:cubicBezTo>
                <a:cubicBezTo>
                  <a:pt x="1158166" y="187858"/>
                  <a:pt x="1160952" y="188061"/>
                  <a:pt x="1188720" y="160293"/>
                </a:cubicBezTo>
                <a:cubicBezTo>
                  <a:pt x="1191260" y="152673"/>
                  <a:pt x="1190660" y="143113"/>
                  <a:pt x="1196340" y="137433"/>
                </a:cubicBezTo>
                <a:cubicBezTo>
                  <a:pt x="1202020" y="131753"/>
                  <a:pt x="1212179" y="133714"/>
                  <a:pt x="1219200" y="129813"/>
                </a:cubicBezTo>
                <a:cubicBezTo>
                  <a:pt x="1235211" y="120918"/>
                  <a:pt x="1249680" y="109493"/>
                  <a:pt x="1264920" y="99333"/>
                </a:cubicBezTo>
                <a:lnTo>
                  <a:pt x="1287780" y="84093"/>
                </a:lnTo>
                <a:cubicBezTo>
                  <a:pt x="1301683" y="63238"/>
                  <a:pt x="1301817" y="56688"/>
                  <a:pt x="1325880" y="45993"/>
                </a:cubicBezTo>
                <a:cubicBezTo>
                  <a:pt x="1340560" y="39469"/>
                  <a:pt x="1356360" y="35833"/>
                  <a:pt x="1371600" y="30753"/>
                </a:cubicBezTo>
                <a:cubicBezTo>
                  <a:pt x="1379220" y="28213"/>
                  <a:pt x="1387777" y="27588"/>
                  <a:pt x="1394460" y="23133"/>
                </a:cubicBezTo>
                <a:cubicBezTo>
                  <a:pt x="1416809" y="8234"/>
                  <a:pt x="1414941" y="6583"/>
                  <a:pt x="1440180" y="273"/>
                </a:cubicBezTo>
                <a:cubicBezTo>
                  <a:pt x="1442644" y="-343"/>
                  <a:pt x="1445260" y="273"/>
                  <a:pt x="1447800" y="273"/>
                </a:cubicBezTo>
              </a:path>
            </a:pathLst>
          </a:custGeom>
          <a:noFill/>
          <a:ln w="19050">
            <a:solidFill>
              <a:schemeClr val="bg2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Freeform 15"/>
          <p:cNvSpPr/>
          <p:nvPr/>
        </p:nvSpPr>
        <p:spPr>
          <a:xfrm>
            <a:off x="2958121" y="3733760"/>
            <a:ext cx="1039624" cy="945038"/>
          </a:xfrm>
          <a:custGeom>
            <a:avLst/>
            <a:gdLst>
              <a:gd name="connsiteX0" fmla="*/ 0 w 1447800"/>
              <a:gd name="connsiteY0" fmla="*/ 1341393 h 1341393"/>
              <a:gd name="connsiteX1" fmla="*/ 60960 w 1447800"/>
              <a:gd name="connsiteY1" fmla="*/ 1295673 h 1341393"/>
              <a:gd name="connsiteX2" fmla="*/ 106680 w 1447800"/>
              <a:gd name="connsiteY2" fmla="*/ 1265193 h 1341393"/>
              <a:gd name="connsiteX3" fmla="*/ 121920 w 1447800"/>
              <a:gd name="connsiteY3" fmla="*/ 1242333 h 1341393"/>
              <a:gd name="connsiteX4" fmla="*/ 129540 w 1447800"/>
              <a:gd name="connsiteY4" fmla="*/ 1219473 h 1341393"/>
              <a:gd name="connsiteX5" fmla="*/ 152400 w 1447800"/>
              <a:gd name="connsiteY5" fmla="*/ 1204233 h 1341393"/>
              <a:gd name="connsiteX6" fmla="*/ 160020 w 1447800"/>
              <a:gd name="connsiteY6" fmla="*/ 1181373 h 1341393"/>
              <a:gd name="connsiteX7" fmla="*/ 198120 w 1447800"/>
              <a:gd name="connsiteY7" fmla="*/ 1128033 h 1341393"/>
              <a:gd name="connsiteX8" fmla="*/ 251460 w 1447800"/>
              <a:gd name="connsiteY8" fmla="*/ 1059453 h 1341393"/>
              <a:gd name="connsiteX9" fmla="*/ 289560 w 1447800"/>
              <a:gd name="connsiteY9" fmla="*/ 990873 h 1341393"/>
              <a:gd name="connsiteX10" fmla="*/ 304800 w 1447800"/>
              <a:gd name="connsiteY10" fmla="*/ 968013 h 1341393"/>
              <a:gd name="connsiteX11" fmla="*/ 335280 w 1447800"/>
              <a:gd name="connsiteY11" fmla="*/ 922293 h 1341393"/>
              <a:gd name="connsiteX12" fmla="*/ 365760 w 1447800"/>
              <a:gd name="connsiteY12" fmla="*/ 884193 h 1341393"/>
              <a:gd name="connsiteX13" fmla="*/ 381000 w 1447800"/>
              <a:gd name="connsiteY13" fmla="*/ 861333 h 1341393"/>
              <a:gd name="connsiteX14" fmla="*/ 403860 w 1447800"/>
              <a:gd name="connsiteY14" fmla="*/ 853713 h 1341393"/>
              <a:gd name="connsiteX15" fmla="*/ 457200 w 1447800"/>
              <a:gd name="connsiteY15" fmla="*/ 815613 h 1341393"/>
              <a:gd name="connsiteX16" fmla="*/ 502920 w 1447800"/>
              <a:gd name="connsiteY16" fmla="*/ 792753 h 1341393"/>
              <a:gd name="connsiteX17" fmla="*/ 525780 w 1447800"/>
              <a:gd name="connsiteY17" fmla="*/ 769893 h 1341393"/>
              <a:gd name="connsiteX18" fmla="*/ 571500 w 1447800"/>
              <a:gd name="connsiteY18" fmla="*/ 739413 h 1341393"/>
              <a:gd name="connsiteX19" fmla="*/ 617220 w 1447800"/>
              <a:gd name="connsiteY19" fmla="*/ 708933 h 1341393"/>
              <a:gd name="connsiteX20" fmla="*/ 640080 w 1447800"/>
              <a:gd name="connsiteY20" fmla="*/ 686073 h 1341393"/>
              <a:gd name="connsiteX21" fmla="*/ 708660 w 1447800"/>
              <a:gd name="connsiteY21" fmla="*/ 632733 h 1341393"/>
              <a:gd name="connsiteX22" fmla="*/ 784860 w 1447800"/>
              <a:gd name="connsiteY22" fmla="*/ 541293 h 1341393"/>
              <a:gd name="connsiteX23" fmla="*/ 807720 w 1447800"/>
              <a:gd name="connsiteY23" fmla="*/ 533673 h 1341393"/>
              <a:gd name="connsiteX24" fmla="*/ 853440 w 1447800"/>
              <a:gd name="connsiteY24" fmla="*/ 495573 h 1341393"/>
              <a:gd name="connsiteX25" fmla="*/ 876300 w 1447800"/>
              <a:gd name="connsiteY25" fmla="*/ 487953 h 1341393"/>
              <a:gd name="connsiteX26" fmla="*/ 944880 w 1447800"/>
              <a:gd name="connsiteY26" fmla="*/ 434613 h 1341393"/>
              <a:gd name="connsiteX27" fmla="*/ 967740 w 1447800"/>
              <a:gd name="connsiteY27" fmla="*/ 419373 h 1341393"/>
              <a:gd name="connsiteX28" fmla="*/ 990600 w 1447800"/>
              <a:gd name="connsiteY28" fmla="*/ 404133 h 1341393"/>
              <a:gd name="connsiteX29" fmla="*/ 1028700 w 1447800"/>
              <a:gd name="connsiteY29" fmla="*/ 373653 h 1341393"/>
              <a:gd name="connsiteX30" fmla="*/ 1051560 w 1447800"/>
              <a:gd name="connsiteY30" fmla="*/ 350793 h 1341393"/>
              <a:gd name="connsiteX31" fmla="*/ 1097280 w 1447800"/>
              <a:gd name="connsiteY31" fmla="*/ 312693 h 1341393"/>
              <a:gd name="connsiteX32" fmla="*/ 1127760 w 1447800"/>
              <a:gd name="connsiteY32" fmla="*/ 251733 h 1341393"/>
              <a:gd name="connsiteX33" fmla="*/ 1135380 w 1447800"/>
              <a:gd name="connsiteY33" fmla="*/ 228873 h 1341393"/>
              <a:gd name="connsiteX34" fmla="*/ 1188720 w 1447800"/>
              <a:gd name="connsiteY34" fmla="*/ 160293 h 1341393"/>
              <a:gd name="connsiteX35" fmla="*/ 1196340 w 1447800"/>
              <a:gd name="connsiteY35" fmla="*/ 137433 h 1341393"/>
              <a:gd name="connsiteX36" fmla="*/ 1219200 w 1447800"/>
              <a:gd name="connsiteY36" fmla="*/ 129813 h 1341393"/>
              <a:gd name="connsiteX37" fmla="*/ 1264920 w 1447800"/>
              <a:gd name="connsiteY37" fmla="*/ 99333 h 1341393"/>
              <a:gd name="connsiteX38" fmla="*/ 1287780 w 1447800"/>
              <a:gd name="connsiteY38" fmla="*/ 84093 h 1341393"/>
              <a:gd name="connsiteX39" fmla="*/ 1325880 w 1447800"/>
              <a:gd name="connsiteY39" fmla="*/ 45993 h 1341393"/>
              <a:gd name="connsiteX40" fmla="*/ 1371600 w 1447800"/>
              <a:gd name="connsiteY40" fmla="*/ 30753 h 1341393"/>
              <a:gd name="connsiteX41" fmla="*/ 1394460 w 1447800"/>
              <a:gd name="connsiteY41" fmla="*/ 23133 h 1341393"/>
              <a:gd name="connsiteX42" fmla="*/ 1440180 w 1447800"/>
              <a:gd name="connsiteY42" fmla="*/ 273 h 1341393"/>
              <a:gd name="connsiteX43" fmla="*/ 1447800 w 1447800"/>
              <a:gd name="connsiteY43" fmla="*/ 273 h 13413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</a:cxnLst>
            <a:rect l="l" t="t" r="r" b="b"/>
            <a:pathLst>
              <a:path w="1447800" h="1341393">
                <a:moveTo>
                  <a:pt x="0" y="1341393"/>
                </a:moveTo>
                <a:cubicBezTo>
                  <a:pt x="88388" y="1253005"/>
                  <a:pt x="1112" y="1328922"/>
                  <a:pt x="60960" y="1295673"/>
                </a:cubicBezTo>
                <a:cubicBezTo>
                  <a:pt x="76971" y="1286778"/>
                  <a:pt x="106680" y="1265193"/>
                  <a:pt x="106680" y="1265193"/>
                </a:cubicBezTo>
                <a:cubicBezTo>
                  <a:pt x="111760" y="1257573"/>
                  <a:pt x="117824" y="1250524"/>
                  <a:pt x="121920" y="1242333"/>
                </a:cubicBezTo>
                <a:cubicBezTo>
                  <a:pt x="125512" y="1235149"/>
                  <a:pt x="124522" y="1225745"/>
                  <a:pt x="129540" y="1219473"/>
                </a:cubicBezTo>
                <a:cubicBezTo>
                  <a:pt x="135261" y="1212322"/>
                  <a:pt x="144780" y="1209313"/>
                  <a:pt x="152400" y="1204233"/>
                </a:cubicBezTo>
                <a:cubicBezTo>
                  <a:pt x="154940" y="1196613"/>
                  <a:pt x="156428" y="1188557"/>
                  <a:pt x="160020" y="1181373"/>
                </a:cubicBezTo>
                <a:cubicBezTo>
                  <a:pt x="164844" y="1171724"/>
                  <a:pt x="193978" y="1132865"/>
                  <a:pt x="198120" y="1128033"/>
                </a:cubicBezTo>
                <a:cubicBezTo>
                  <a:pt x="219637" y="1102930"/>
                  <a:pt x="239298" y="1095939"/>
                  <a:pt x="251460" y="1059453"/>
                </a:cubicBezTo>
                <a:cubicBezTo>
                  <a:pt x="264872" y="1019217"/>
                  <a:pt x="254625" y="1043276"/>
                  <a:pt x="289560" y="990873"/>
                </a:cubicBezTo>
                <a:cubicBezTo>
                  <a:pt x="294640" y="983253"/>
                  <a:pt x="301904" y="976701"/>
                  <a:pt x="304800" y="968013"/>
                </a:cubicBezTo>
                <a:cubicBezTo>
                  <a:pt x="315828" y="934930"/>
                  <a:pt x="306740" y="950833"/>
                  <a:pt x="335280" y="922293"/>
                </a:cubicBezTo>
                <a:cubicBezTo>
                  <a:pt x="350115" y="877789"/>
                  <a:pt x="331293" y="918660"/>
                  <a:pt x="365760" y="884193"/>
                </a:cubicBezTo>
                <a:cubicBezTo>
                  <a:pt x="372236" y="877717"/>
                  <a:pt x="373849" y="867054"/>
                  <a:pt x="381000" y="861333"/>
                </a:cubicBezTo>
                <a:cubicBezTo>
                  <a:pt x="387272" y="856315"/>
                  <a:pt x="396676" y="857305"/>
                  <a:pt x="403860" y="853713"/>
                </a:cubicBezTo>
                <a:cubicBezTo>
                  <a:pt x="427447" y="841919"/>
                  <a:pt x="433039" y="829419"/>
                  <a:pt x="457200" y="815613"/>
                </a:cubicBezTo>
                <a:cubicBezTo>
                  <a:pt x="500939" y="790619"/>
                  <a:pt x="459477" y="828956"/>
                  <a:pt x="502920" y="792753"/>
                </a:cubicBezTo>
                <a:cubicBezTo>
                  <a:pt x="511199" y="785854"/>
                  <a:pt x="517274" y="776509"/>
                  <a:pt x="525780" y="769893"/>
                </a:cubicBezTo>
                <a:cubicBezTo>
                  <a:pt x="540238" y="758648"/>
                  <a:pt x="558548" y="752365"/>
                  <a:pt x="571500" y="739413"/>
                </a:cubicBezTo>
                <a:cubicBezTo>
                  <a:pt x="600040" y="710873"/>
                  <a:pt x="584137" y="719961"/>
                  <a:pt x="617220" y="708933"/>
                </a:cubicBezTo>
                <a:cubicBezTo>
                  <a:pt x="624840" y="701313"/>
                  <a:pt x="631574" y="692689"/>
                  <a:pt x="640080" y="686073"/>
                </a:cubicBezTo>
                <a:cubicBezTo>
                  <a:pt x="672491" y="660865"/>
                  <a:pt x="685954" y="661926"/>
                  <a:pt x="708660" y="632733"/>
                </a:cubicBezTo>
                <a:cubicBezTo>
                  <a:pt x="725740" y="610773"/>
                  <a:pt x="756024" y="550905"/>
                  <a:pt x="784860" y="541293"/>
                </a:cubicBezTo>
                <a:lnTo>
                  <a:pt x="807720" y="533673"/>
                </a:lnTo>
                <a:cubicBezTo>
                  <a:pt x="824572" y="516821"/>
                  <a:pt x="832222" y="506182"/>
                  <a:pt x="853440" y="495573"/>
                </a:cubicBezTo>
                <a:cubicBezTo>
                  <a:pt x="860624" y="491981"/>
                  <a:pt x="868680" y="490493"/>
                  <a:pt x="876300" y="487953"/>
                </a:cubicBezTo>
                <a:cubicBezTo>
                  <a:pt x="912112" y="452141"/>
                  <a:pt x="890194" y="471071"/>
                  <a:pt x="944880" y="434613"/>
                </a:cubicBezTo>
                <a:lnTo>
                  <a:pt x="967740" y="419373"/>
                </a:lnTo>
                <a:lnTo>
                  <a:pt x="990600" y="404133"/>
                </a:lnTo>
                <a:cubicBezTo>
                  <a:pt x="1024684" y="353008"/>
                  <a:pt x="984533" y="403098"/>
                  <a:pt x="1028700" y="373653"/>
                </a:cubicBezTo>
                <a:cubicBezTo>
                  <a:pt x="1037666" y="367675"/>
                  <a:pt x="1043281" y="357692"/>
                  <a:pt x="1051560" y="350793"/>
                </a:cubicBezTo>
                <a:cubicBezTo>
                  <a:pt x="1115213" y="297749"/>
                  <a:pt x="1030494" y="379479"/>
                  <a:pt x="1097280" y="312693"/>
                </a:cubicBezTo>
                <a:cubicBezTo>
                  <a:pt x="1114463" y="261144"/>
                  <a:pt x="1091770" y="323713"/>
                  <a:pt x="1127760" y="251733"/>
                </a:cubicBezTo>
                <a:cubicBezTo>
                  <a:pt x="1131352" y="244549"/>
                  <a:pt x="1131479" y="235894"/>
                  <a:pt x="1135380" y="228873"/>
                </a:cubicBezTo>
                <a:cubicBezTo>
                  <a:pt x="1158166" y="187858"/>
                  <a:pt x="1160952" y="188061"/>
                  <a:pt x="1188720" y="160293"/>
                </a:cubicBezTo>
                <a:cubicBezTo>
                  <a:pt x="1191260" y="152673"/>
                  <a:pt x="1190660" y="143113"/>
                  <a:pt x="1196340" y="137433"/>
                </a:cubicBezTo>
                <a:cubicBezTo>
                  <a:pt x="1202020" y="131753"/>
                  <a:pt x="1212179" y="133714"/>
                  <a:pt x="1219200" y="129813"/>
                </a:cubicBezTo>
                <a:cubicBezTo>
                  <a:pt x="1235211" y="120918"/>
                  <a:pt x="1249680" y="109493"/>
                  <a:pt x="1264920" y="99333"/>
                </a:cubicBezTo>
                <a:lnTo>
                  <a:pt x="1287780" y="84093"/>
                </a:lnTo>
                <a:cubicBezTo>
                  <a:pt x="1301683" y="63238"/>
                  <a:pt x="1301817" y="56688"/>
                  <a:pt x="1325880" y="45993"/>
                </a:cubicBezTo>
                <a:cubicBezTo>
                  <a:pt x="1340560" y="39469"/>
                  <a:pt x="1356360" y="35833"/>
                  <a:pt x="1371600" y="30753"/>
                </a:cubicBezTo>
                <a:cubicBezTo>
                  <a:pt x="1379220" y="28213"/>
                  <a:pt x="1387777" y="27588"/>
                  <a:pt x="1394460" y="23133"/>
                </a:cubicBezTo>
                <a:cubicBezTo>
                  <a:pt x="1416809" y="8234"/>
                  <a:pt x="1414941" y="6583"/>
                  <a:pt x="1440180" y="273"/>
                </a:cubicBezTo>
                <a:cubicBezTo>
                  <a:pt x="1442644" y="-343"/>
                  <a:pt x="1445260" y="273"/>
                  <a:pt x="1447800" y="273"/>
                </a:cubicBezTo>
              </a:path>
            </a:pathLst>
          </a:custGeom>
          <a:noFill/>
          <a:ln w="19050">
            <a:solidFill>
              <a:schemeClr val="bg2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Freeform 16"/>
          <p:cNvSpPr/>
          <p:nvPr/>
        </p:nvSpPr>
        <p:spPr>
          <a:xfrm>
            <a:off x="1848979" y="3749028"/>
            <a:ext cx="1039624" cy="945038"/>
          </a:xfrm>
          <a:custGeom>
            <a:avLst/>
            <a:gdLst>
              <a:gd name="connsiteX0" fmla="*/ 0 w 1447800"/>
              <a:gd name="connsiteY0" fmla="*/ 1341393 h 1341393"/>
              <a:gd name="connsiteX1" fmla="*/ 60960 w 1447800"/>
              <a:gd name="connsiteY1" fmla="*/ 1295673 h 1341393"/>
              <a:gd name="connsiteX2" fmla="*/ 106680 w 1447800"/>
              <a:gd name="connsiteY2" fmla="*/ 1265193 h 1341393"/>
              <a:gd name="connsiteX3" fmla="*/ 121920 w 1447800"/>
              <a:gd name="connsiteY3" fmla="*/ 1242333 h 1341393"/>
              <a:gd name="connsiteX4" fmla="*/ 129540 w 1447800"/>
              <a:gd name="connsiteY4" fmla="*/ 1219473 h 1341393"/>
              <a:gd name="connsiteX5" fmla="*/ 152400 w 1447800"/>
              <a:gd name="connsiteY5" fmla="*/ 1204233 h 1341393"/>
              <a:gd name="connsiteX6" fmla="*/ 160020 w 1447800"/>
              <a:gd name="connsiteY6" fmla="*/ 1181373 h 1341393"/>
              <a:gd name="connsiteX7" fmla="*/ 198120 w 1447800"/>
              <a:gd name="connsiteY7" fmla="*/ 1128033 h 1341393"/>
              <a:gd name="connsiteX8" fmla="*/ 251460 w 1447800"/>
              <a:gd name="connsiteY8" fmla="*/ 1059453 h 1341393"/>
              <a:gd name="connsiteX9" fmla="*/ 289560 w 1447800"/>
              <a:gd name="connsiteY9" fmla="*/ 990873 h 1341393"/>
              <a:gd name="connsiteX10" fmla="*/ 304800 w 1447800"/>
              <a:gd name="connsiteY10" fmla="*/ 968013 h 1341393"/>
              <a:gd name="connsiteX11" fmla="*/ 335280 w 1447800"/>
              <a:gd name="connsiteY11" fmla="*/ 922293 h 1341393"/>
              <a:gd name="connsiteX12" fmla="*/ 365760 w 1447800"/>
              <a:gd name="connsiteY12" fmla="*/ 884193 h 1341393"/>
              <a:gd name="connsiteX13" fmla="*/ 381000 w 1447800"/>
              <a:gd name="connsiteY13" fmla="*/ 861333 h 1341393"/>
              <a:gd name="connsiteX14" fmla="*/ 403860 w 1447800"/>
              <a:gd name="connsiteY14" fmla="*/ 853713 h 1341393"/>
              <a:gd name="connsiteX15" fmla="*/ 457200 w 1447800"/>
              <a:gd name="connsiteY15" fmla="*/ 815613 h 1341393"/>
              <a:gd name="connsiteX16" fmla="*/ 502920 w 1447800"/>
              <a:gd name="connsiteY16" fmla="*/ 792753 h 1341393"/>
              <a:gd name="connsiteX17" fmla="*/ 525780 w 1447800"/>
              <a:gd name="connsiteY17" fmla="*/ 769893 h 1341393"/>
              <a:gd name="connsiteX18" fmla="*/ 571500 w 1447800"/>
              <a:gd name="connsiteY18" fmla="*/ 739413 h 1341393"/>
              <a:gd name="connsiteX19" fmla="*/ 617220 w 1447800"/>
              <a:gd name="connsiteY19" fmla="*/ 708933 h 1341393"/>
              <a:gd name="connsiteX20" fmla="*/ 640080 w 1447800"/>
              <a:gd name="connsiteY20" fmla="*/ 686073 h 1341393"/>
              <a:gd name="connsiteX21" fmla="*/ 708660 w 1447800"/>
              <a:gd name="connsiteY21" fmla="*/ 632733 h 1341393"/>
              <a:gd name="connsiteX22" fmla="*/ 784860 w 1447800"/>
              <a:gd name="connsiteY22" fmla="*/ 541293 h 1341393"/>
              <a:gd name="connsiteX23" fmla="*/ 807720 w 1447800"/>
              <a:gd name="connsiteY23" fmla="*/ 533673 h 1341393"/>
              <a:gd name="connsiteX24" fmla="*/ 853440 w 1447800"/>
              <a:gd name="connsiteY24" fmla="*/ 495573 h 1341393"/>
              <a:gd name="connsiteX25" fmla="*/ 876300 w 1447800"/>
              <a:gd name="connsiteY25" fmla="*/ 487953 h 1341393"/>
              <a:gd name="connsiteX26" fmla="*/ 944880 w 1447800"/>
              <a:gd name="connsiteY26" fmla="*/ 434613 h 1341393"/>
              <a:gd name="connsiteX27" fmla="*/ 967740 w 1447800"/>
              <a:gd name="connsiteY27" fmla="*/ 419373 h 1341393"/>
              <a:gd name="connsiteX28" fmla="*/ 990600 w 1447800"/>
              <a:gd name="connsiteY28" fmla="*/ 404133 h 1341393"/>
              <a:gd name="connsiteX29" fmla="*/ 1028700 w 1447800"/>
              <a:gd name="connsiteY29" fmla="*/ 373653 h 1341393"/>
              <a:gd name="connsiteX30" fmla="*/ 1051560 w 1447800"/>
              <a:gd name="connsiteY30" fmla="*/ 350793 h 1341393"/>
              <a:gd name="connsiteX31" fmla="*/ 1097280 w 1447800"/>
              <a:gd name="connsiteY31" fmla="*/ 312693 h 1341393"/>
              <a:gd name="connsiteX32" fmla="*/ 1127760 w 1447800"/>
              <a:gd name="connsiteY32" fmla="*/ 251733 h 1341393"/>
              <a:gd name="connsiteX33" fmla="*/ 1135380 w 1447800"/>
              <a:gd name="connsiteY33" fmla="*/ 228873 h 1341393"/>
              <a:gd name="connsiteX34" fmla="*/ 1188720 w 1447800"/>
              <a:gd name="connsiteY34" fmla="*/ 160293 h 1341393"/>
              <a:gd name="connsiteX35" fmla="*/ 1196340 w 1447800"/>
              <a:gd name="connsiteY35" fmla="*/ 137433 h 1341393"/>
              <a:gd name="connsiteX36" fmla="*/ 1219200 w 1447800"/>
              <a:gd name="connsiteY36" fmla="*/ 129813 h 1341393"/>
              <a:gd name="connsiteX37" fmla="*/ 1264920 w 1447800"/>
              <a:gd name="connsiteY37" fmla="*/ 99333 h 1341393"/>
              <a:gd name="connsiteX38" fmla="*/ 1287780 w 1447800"/>
              <a:gd name="connsiteY38" fmla="*/ 84093 h 1341393"/>
              <a:gd name="connsiteX39" fmla="*/ 1325880 w 1447800"/>
              <a:gd name="connsiteY39" fmla="*/ 45993 h 1341393"/>
              <a:gd name="connsiteX40" fmla="*/ 1371600 w 1447800"/>
              <a:gd name="connsiteY40" fmla="*/ 30753 h 1341393"/>
              <a:gd name="connsiteX41" fmla="*/ 1394460 w 1447800"/>
              <a:gd name="connsiteY41" fmla="*/ 23133 h 1341393"/>
              <a:gd name="connsiteX42" fmla="*/ 1440180 w 1447800"/>
              <a:gd name="connsiteY42" fmla="*/ 273 h 1341393"/>
              <a:gd name="connsiteX43" fmla="*/ 1447800 w 1447800"/>
              <a:gd name="connsiteY43" fmla="*/ 273 h 13413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</a:cxnLst>
            <a:rect l="l" t="t" r="r" b="b"/>
            <a:pathLst>
              <a:path w="1447800" h="1341393">
                <a:moveTo>
                  <a:pt x="0" y="1341393"/>
                </a:moveTo>
                <a:cubicBezTo>
                  <a:pt x="88388" y="1253005"/>
                  <a:pt x="1112" y="1328922"/>
                  <a:pt x="60960" y="1295673"/>
                </a:cubicBezTo>
                <a:cubicBezTo>
                  <a:pt x="76971" y="1286778"/>
                  <a:pt x="106680" y="1265193"/>
                  <a:pt x="106680" y="1265193"/>
                </a:cubicBezTo>
                <a:cubicBezTo>
                  <a:pt x="111760" y="1257573"/>
                  <a:pt x="117824" y="1250524"/>
                  <a:pt x="121920" y="1242333"/>
                </a:cubicBezTo>
                <a:cubicBezTo>
                  <a:pt x="125512" y="1235149"/>
                  <a:pt x="124522" y="1225745"/>
                  <a:pt x="129540" y="1219473"/>
                </a:cubicBezTo>
                <a:cubicBezTo>
                  <a:pt x="135261" y="1212322"/>
                  <a:pt x="144780" y="1209313"/>
                  <a:pt x="152400" y="1204233"/>
                </a:cubicBezTo>
                <a:cubicBezTo>
                  <a:pt x="154940" y="1196613"/>
                  <a:pt x="156428" y="1188557"/>
                  <a:pt x="160020" y="1181373"/>
                </a:cubicBezTo>
                <a:cubicBezTo>
                  <a:pt x="164844" y="1171724"/>
                  <a:pt x="193978" y="1132865"/>
                  <a:pt x="198120" y="1128033"/>
                </a:cubicBezTo>
                <a:cubicBezTo>
                  <a:pt x="219637" y="1102930"/>
                  <a:pt x="239298" y="1095939"/>
                  <a:pt x="251460" y="1059453"/>
                </a:cubicBezTo>
                <a:cubicBezTo>
                  <a:pt x="264872" y="1019217"/>
                  <a:pt x="254625" y="1043276"/>
                  <a:pt x="289560" y="990873"/>
                </a:cubicBezTo>
                <a:cubicBezTo>
                  <a:pt x="294640" y="983253"/>
                  <a:pt x="301904" y="976701"/>
                  <a:pt x="304800" y="968013"/>
                </a:cubicBezTo>
                <a:cubicBezTo>
                  <a:pt x="315828" y="934930"/>
                  <a:pt x="306740" y="950833"/>
                  <a:pt x="335280" y="922293"/>
                </a:cubicBezTo>
                <a:cubicBezTo>
                  <a:pt x="350115" y="877789"/>
                  <a:pt x="331293" y="918660"/>
                  <a:pt x="365760" y="884193"/>
                </a:cubicBezTo>
                <a:cubicBezTo>
                  <a:pt x="372236" y="877717"/>
                  <a:pt x="373849" y="867054"/>
                  <a:pt x="381000" y="861333"/>
                </a:cubicBezTo>
                <a:cubicBezTo>
                  <a:pt x="387272" y="856315"/>
                  <a:pt x="396676" y="857305"/>
                  <a:pt x="403860" y="853713"/>
                </a:cubicBezTo>
                <a:cubicBezTo>
                  <a:pt x="427447" y="841919"/>
                  <a:pt x="433039" y="829419"/>
                  <a:pt x="457200" y="815613"/>
                </a:cubicBezTo>
                <a:cubicBezTo>
                  <a:pt x="500939" y="790619"/>
                  <a:pt x="459477" y="828956"/>
                  <a:pt x="502920" y="792753"/>
                </a:cubicBezTo>
                <a:cubicBezTo>
                  <a:pt x="511199" y="785854"/>
                  <a:pt x="517274" y="776509"/>
                  <a:pt x="525780" y="769893"/>
                </a:cubicBezTo>
                <a:cubicBezTo>
                  <a:pt x="540238" y="758648"/>
                  <a:pt x="558548" y="752365"/>
                  <a:pt x="571500" y="739413"/>
                </a:cubicBezTo>
                <a:cubicBezTo>
                  <a:pt x="600040" y="710873"/>
                  <a:pt x="584137" y="719961"/>
                  <a:pt x="617220" y="708933"/>
                </a:cubicBezTo>
                <a:cubicBezTo>
                  <a:pt x="624840" y="701313"/>
                  <a:pt x="631574" y="692689"/>
                  <a:pt x="640080" y="686073"/>
                </a:cubicBezTo>
                <a:cubicBezTo>
                  <a:pt x="672491" y="660865"/>
                  <a:pt x="685954" y="661926"/>
                  <a:pt x="708660" y="632733"/>
                </a:cubicBezTo>
                <a:cubicBezTo>
                  <a:pt x="725740" y="610773"/>
                  <a:pt x="756024" y="550905"/>
                  <a:pt x="784860" y="541293"/>
                </a:cubicBezTo>
                <a:lnTo>
                  <a:pt x="807720" y="533673"/>
                </a:lnTo>
                <a:cubicBezTo>
                  <a:pt x="824572" y="516821"/>
                  <a:pt x="832222" y="506182"/>
                  <a:pt x="853440" y="495573"/>
                </a:cubicBezTo>
                <a:cubicBezTo>
                  <a:pt x="860624" y="491981"/>
                  <a:pt x="868680" y="490493"/>
                  <a:pt x="876300" y="487953"/>
                </a:cubicBezTo>
                <a:cubicBezTo>
                  <a:pt x="912112" y="452141"/>
                  <a:pt x="890194" y="471071"/>
                  <a:pt x="944880" y="434613"/>
                </a:cubicBezTo>
                <a:lnTo>
                  <a:pt x="967740" y="419373"/>
                </a:lnTo>
                <a:lnTo>
                  <a:pt x="990600" y="404133"/>
                </a:lnTo>
                <a:cubicBezTo>
                  <a:pt x="1024684" y="353008"/>
                  <a:pt x="984533" y="403098"/>
                  <a:pt x="1028700" y="373653"/>
                </a:cubicBezTo>
                <a:cubicBezTo>
                  <a:pt x="1037666" y="367675"/>
                  <a:pt x="1043281" y="357692"/>
                  <a:pt x="1051560" y="350793"/>
                </a:cubicBezTo>
                <a:cubicBezTo>
                  <a:pt x="1115213" y="297749"/>
                  <a:pt x="1030494" y="379479"/>
                  <a:pt x="1097280" y="312693"/>
                </a:cubicBezTo>
                <a:cubicBezTo>
                  <a:pt x="1114463" y="261144"/>
                  <a:pt x="1091770" y="323713"/>
                  <a:pt x="1127760" y="251733"/>
                </a:cubicBezTo>
                <a:cubicBezTo>
                  <a:pt x="1131352" y="244549"/>
                  <a:pt x="1131479" y="235894"/>
                  <a:pt x="1135380" y="228873"/>
                </a:cubicBezTo>
                <a:cubicBezTo>
                  <a:pt x="1158166" y="187858"/>
                  <a:pt x="1160952" y="188061"/>
                  <a:pt x="1188720" y="160293"/>
                </a:cubicBezTo>
                <a:cubicBezTo>
                  <a:pt x="1191260" y="152673"/>
                  <a:pt x="1190660" y="143113"/>
                  <a:pt x="1196340" y="137433"/>
                </a:cubicBezTo>
                <a:cubicBezTo>
                  <a:pt x="1202020" y="131753"/>
                  <a:pt x="1212179" y="133714"/>
                  <a:pt x="1219200" y="129813"/>
                </a:cubicBezTo>
                <a:cubicBezTo>
                  <a:pt x="1235211" y="120918"/>
                  <a:pt x="1249680" y="109493"/>
                  <a:pt x="1264920" y="99333"/>
                </a:cubicBezTo>
                <a:lnTo>
                  <a:pt x="1287780" y="84093"/>
                </a:lnTo>
                <a:cubicBezTo>
                  <a:pt x="1301683" y="63238"/>
                  <a:pt x="1301817" y="56688"/>
                  <a:pt x="1325880" y="45993"/>
                </a:cubicBezTo>
                <a:cubicBezTo>
                  <a:pt x="1340560" y="39469"/>
                  <a:pt x="1356360" y="35833"/>
                  <a:pt x="1371600" y="30753"/>
                </a:cubicBezTo>
                <a:cubicBezTo>
                  <a:pt x="1379220" y="28213"/>
                  <a:pt x="1387777" y="27588"/>
                  <a:pt x="1394460" y="23133"/>
                </a:cubicBezTo>
                <a:cubicBezTo>
                  <a:pt x="1416809" y="8234"/>
                  <a:pt x="1414941" y="6583"/>
                  <a:pt x="1440180" y="273"/>
                </a:cubicBezTo>
                <a:cubicBezTo>
                  <a:pt x="1442644" y="-343"/>
                  <a:pt x="1445260" y="273"/>
                  <a:pt x="1447800" y="273"/>
                </a:cubicBezTo>
              </a:path>
            </a:pathLst>
          </a:custGeom>
          <a:noFill/>
          <a:ln w="19050">
            <a:solidFill>
              <a:schemeClr val="bg2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Freeform 17"/>
          <p:cNvSpPr/>
          <p:nvPr/>
        </p:nvSpPr>
        <p:spPr>
          <a:xfrm>
            <a:off x="755164" y="3745831"/>
            <a:ext cx="1039624" cy="945038"/>
          </a:xfrm>
          <a:custGeom>
            <a:avLst/>
            <a:gdLst>
              <a:gd name="connsiteX0" fmla="*/ 0 w 1447800"/>
              <a:gd name="connsiteY0" fmla="*/ 1341393 h 1341393"/>
              <a:gd name="connsiteX1" fmla="*/ 60960 w 1447800"/>
              <a:gd name="connsiteY1" fmla="*/ 1295673 h 1341393"/>
              <a:gd name="connsiteX2" fmla="*/ 106680 w 1447800"/>
              <a:gd name="connsiteY2" fmla="*/ 1265193 h 1341393"/>
              <a:gd name="connsiteX3" fmla="*/ 121920 w 1447800"/>
              <a:gd name="connsiteY3" fmla="*/ 1242333 h 1341393"/>
              <a:gd name="connsiteX4" fmla="*/ 129540 w 1447800"/>
              <a:gd name="connsiteY4" fmla="*/ 1219473 h 1341393"/>
              <a:gd name="connsiteX5" fmla="*/ 152400 w 1447800"/>
              <a:gd name="connsiteY5" fmla="*/ 1204233 h 1341393"/>
              <a:gd name="connsiteX6" fmla="*/ 160020 w 1447800"/>
              <a:gd name="connsiteY6" fmla="*/ 1181373 h 1341393"/>
              <a:gd name="connsiteX7" fmla="*/ 198120 w 1447800"/>
              <a:gd name="connsiteY7" fmla="*/ 1128033 h 1341393"/>
              <a:gd name="connsiteX8" fmla="*/ 251460 w 1447800"/>
              <a:gd name="connsiteY8" fmla="*/ 1059453 h 1341393"/>
              <a:gd name="connsiteX9" fmla="*/ 289560 w 1447800"/>
              <a:gd name="connsiteY9" fmla="*/ 990873 h 1341393"/>
              <a:gd name="connsiteX10" fmla="*/ 304800 w 1447800"/>
              <a:gd name="connsiteY10" fmla="*/ 968013 h 1341393"/>
              <a:gd name="connsiteX11" fmla="*/ 335280 w 1447800"/>
              <a:gd name="connsiteY11" fmla="*/ 922293 h 1341393"/>
              <a:gd name="connsiteX12" fmla="*/ 365760 w 1447800"/>
              <a:gd name="connsiteY12" fmla="*/ 884193 h 1341393"/>
              <a:gd name="connsiteX13" fmla="*/ 381000 w 1447800"/>
              <a:gd name="connsiteY13" fmla="*/ 861333 h 1341393"/>
              <a:gd name="connsiteX14" fmla="*/ 403860 w 1447800"/>
              <a:gd name="connsiteY14" fmla="*/ 853713 h 1341393"/>
              <a:gd name="connsiteX15" fmla="*/ 457200 w 1447800"/>
              <a:gd name="connsiteY15" fmla="*/ 815613 h 1341393"/>
              <a:gd name="connsiteX16" fmla="*/ 502920 w 1447800"/>
              <a:gd name="connsiteY16" fmla="*/ 792753 h 1341393"/>
              <a:gd name="connsiteX17" fmla="*/ 525780 w 1447800"/>
              <a:gd name="connsiteY17" fmla="*/ 769893 h 1341393"/>
              <a:gd name="connsiteX18" fmla="*/ 571500 w 1447800"/>
              <a:gd name="connsiteY18" fmla="*/ 739413 h 1341393"/>
              <a:gd name="connsiteX19" fmla="*/ 617220 w 1447800"/>
              <a:gd name="connsiteY19" fmla="*/ 708933 h 1341393"/>
              <a:gd name="connsiteX20" fmla="*/ 640080 w 1447800"/>
              <a:gd name="connsiteY20" fmla="*/ 686073 h 1341393"/>
              <a:gd name="connsiteX21" fmla="*/ 708660 w 1447800"/>
              <a:gd name="connsiteY21" fmla="*/ 632733 h 1341393"/>
              <a:gd name="connsiteX22" fmla="*/ 784860 w 1447800"/>
              <a:gd name="connsiteY22" fmla="*/ 541293 h 1341393"/>
              <a:gd name="connsiteX23" fmla="*/ 807720 w 1447800"/>
              <a:gd name="connsiteY23" fmla="*/ 533673 h 1341393"/>
              <a:gd name="connsiteX24" fmla="*/ 853440 w 1447800"/>
              <a:gd name="connsiteY24" fmla="*/ 495573 h 1341393"/>
              <a:gd name="connsiteX25" fmla="*/ 876300 w 1447800"/>
              <a:gd name="connsiteY25" fmla="*/ 487953 h 1341393"/>
              <a:gd name="connsiteX26" fmla="*/ 944880 w 1447800"/>
              <a:gd name="connsiteY26" fmla="*/ 434613 h 1341393"/>
              <a:gd name="connsiteX27" fmla="*/ 967740 w 1447800"/>
              <a:gd name="connsiteY27" fmla="*/ 419373 h 1341393"/>
              <a:gd name="connsiteX28" fmla="*/ 990600 w 1447800"/>
              <a:gd name="connsiteY28" fmla="*/ 404133 h 1341393"/>
              <a:gd name="connsiteX29" fmla="*/ 1028700 w 1447800"/>
              <a:gd name="connsiteY29" fmla="*/ 373653 h 1341393"/>
              <a:gd name="connsiteX30" fmla="*/ 1051560 w 1447800"/>
              <a:gd name="connsiteY30" fmla="*/ 350793 h 1341393"/>
              <a:gd name="connsiteX31" fmla="*/ 1097280 w 1447800"/>
              <a:gd name="connsiteY31" fmla="*/ 312693 h 1341393"/>
              <a:gd name="connsiteX32" fmla="*/ 1127760 w 1447800"/>
              <a:gd name="connsiteY32" fmla="*/ 251733 h 1341393"/>
              <a:gd name="connsiteX33" fmla="*/ 1135380 w 1447800"/>
              <a:gd name="connsiteY33" fmla="*/ 228873 h 1341393"/>
              <a:gd name="connsiteX34" fmla="*/ 1188720 w 1447800"/>
              <a:gd name="connsiteY34" fmla="*/ 160293 h 1341393"/>
              <a:gd name="connsiteX35" fmla="*/ 1196340 w 1447800"/>
              <a:gd name="connsiteY35" fmla="*/ 137433 h 1341393"/>
              <a:gd name="connsiteX36" fmla="*/ 1219200 w 1447800"/>
              <a:gd name="connsiteY36" fmla="*/ 129813 h 1341393"/>
              <a:gd name="connsiteX37" fmla="*/ 1264920 w 1447800"/>
              <a:gd name="connsiteY37" fmla="*/ 99333 h 1341393"/>
              <a:gd name="connsiteX38" fmla="*/ 1287780 w 1447800"/>
              <a:gd name="connsiteY38" fmla="*/ 84093 h 1341393"/>
              <a:gd name="connsiteX39" fmla="*/ 1325880 w 1447800"/>
              <a:gd name="connsiteY39" fmla="*/ 45993 h 1341393"/>
              <a:gd name="connsiteX40" fmla="*/ 1371600 w 1447800"/>
              <a:gd name="connsiteY40" fmla="*/ 30753 h 1341393"/>
              <a:gd name="connsiteX41" fmla="*/ 1394460 w 1447800"/>
              <a:gd name="connsiteY41" fmla="*/ 23133 h 1341393"/>
              <a:gd name="connsiteX42" fmla="*/ 1440180 w 1447800"/>
              <a:gd name="connsiteY42" fmla="*/ 273 h 1341393"/>
              <a:gd name="connsiteX43" fmla="*/ 1447800 w 1447800"/>
              <a:gd name="connsiteY43" fmla="*/ 273 h 13413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</a:cxnLst>
            <a:rect l="l" t="t" r="r" b="b"/>
            <a:pathLst>
              <a:path w="1447800" h="1341393">
                <a:moveTo>
                  <a:pt x="0" y="1341393"/>
                </a:moveTo>
                <a:cubicBezTo>
                  <a:pt x="88388" y="1253005"/>
                  <a:pt x="1112" y="1328922"/>
                  <a:pt x="60960" y="1295673"/>
                </a:cubicBezTo>
                <a:cubicBezTo>
                  <a:pt x="76971" y="1286778"/>
                  <a:pt x="106680" y="1265193"/>
                  <a:pt x="106680" y="1265193"/>
                </a:cubicBezTo>
                <a:cubicBezTo>
                  <a:pt x="111760" y="1257573"/>
                  <a:pt x="117824" y="1250524"/>
                  <a:pt x="121920" y="1242333"/>
                </a:cubicBezTo>
                <a:cubicBezTo>
                  <a:pt x="125512" y="1235149"/>
                  <a:pt x="124522" y="1225745"/>
                  <a:pt x="129540" y="1219473"/>
                </a:cubicBezTo>
                <a:cubicBezTo>
                  <a:pt x="135261" y="1212322"/>
                  <a:pt x="144780" y="1209313"/>
                  <a:pt x="152400" y="1204233"/>
                </a:cubicBezTo>
                <a:cubicBezTo>
                  <a:pt x="154940" y="1196613"/>
                  <a:pt x="156428" y="1188557"/>
                  <a:pt x="160020" y="1181373"/>
                </a:cubicBezTo>
                <a:cubicBezTo>
                  <a:pt x="164844" y="1171724"/>
                  <a:pt x="193978" y="1132865"/>
                  <a:pt x="198120" y="1128033"/>
                </a:cubicBezTo>
                <a:cubicBezTo>
                  <a:pt x="219637" y="1102930"/>
                  <a:pt x="239298" y="1095939"/>
                  <a:pt x="251460" y="1059453"/>
                </a:cubicBezTo>
                <a:cubicBezTo>
                  <a:pt x="264872" y="1019217"/>
                  <a:pt x="254625" y="1043276"/>
                  <a:pt x="289560" y="990873"/>
                </a:cubicBezTo>
                <a:cubicBezTo>
                  <a:pt x="294640" y="983253"/>
                  <a:pt x="301904" y="976701"/>
                  <a:pt x="304800" y="968013"/>
                </a:cubicBezTo>
                <a:cubicBezTo>
                  <a:pt x="315828" y="934930"/>
                  <a:pt x="306740" y="950833"/>
                  <a:pt x="335280" y="922293"/>
                </a:cubicBezTo>
                <a:cubicBezTo>
                  <a:pt x="350115" y="877789"/>
                  <a:pt x="331293" y="918660"/>
                  <a:pt x="365760" y="884193"/>
                </a:cubicBezTo>
                <a:cubicBezTo>
                  <a:pt x="372236" y="877717"/>
                  <a:pt x="373849" y="867054"/>
                  <a:pt x="381000" y="861333"/>
                </a:cubicBezTo>
                <a:cubicBezTo>
                  <a:pt x="387272" y="856315"/>
                  <a:pt x="396676" y="857305"/>
                  <a:pt x="403860" y="853713"/>
                </a:cubicBezTo>
                <a:cubicBezTo>
                  <a:pt x="427447" y="841919"/>
                  <a:pt x="433039" y="829419"/>
                  <a:pt x="457200" y="815613"/>
                </a:cubicBezTo>
                <a:cubicBezTo>
                  <a:pt x="500939" y="790619"/>
                  <a:pt x="459477" y="828956"/>
                  <a:pt x="502920" y="792753"/>
                </a:cubicBezTo>
                <a:cubicBezTo>
                  <a:pt x="511199" y="785854"/>
                  <a:pt x="517274" y="776509"/>
                  <a:pt x="525780" y="769893"/>
                </a:cubicBezTo>
                <a:cubicBezTo>
                  <a:pt x="540238" y="758648"/>
                  <a:pt x="558548" y="752365"/>
                  <a:pt x="571500" y="739413"/>
                </a:cubicBezTo>
                <a:cubicBezTo>
                  <a:pt x="600040" y="710873"/>
                  <a:pt x="584137" y="719961"/>
                  <a:pt x="617220" y="708933"/>
                </a:cubicBezTo>
                <a:cubicBezTo>
                  <a:pt x="624840" y="701313"/>
                  <a:pt x="631574" y="692689"/>
                  <a:pt x="640080" y="686073"/>
                </a:cubicBezTo>
                <a:cubicBezTo>
                  <a:pt x="672491" y="660865"/>
                  <a:pt x="685954" y="661926"/>
                  <a:pt x="708660" y="632733"/>
                </a:cubicBezTo>
                <a:cubicBezTo>
                  <a:pt x="725740" y="610773"/>
                  <a:pt x="756024" y="550905"/>
                  <a:pt x="784860" y="541293"/>
                </a:cubicBezTo>
                <a:lnTo>
                  <a:pt x="807720" y="533673"/>
                </a:lnTo>
                <a:cubicBezTo>
                  <a:pt x="824572" y="516821"/>
                  <a:pt x="832222" y="506182"/>
                  <a:pt x="853440" y="495573"/>
                </a:cubicBezTo>
                <a:cubicBezTo>
                  <a:pt x="860624" y="491981"/>
                  <a:pt x="868680" y="490493"/>
                  <a:pt x="876300" y="487953"/>
                </a:cubicBezTo>
                <a:cubicBezTo>
                  <a:pt x="912112" y="452141"/>
                  <a:pt x="890194" y="471071"/>
                  <a:pt x="944880" y="434613"/>
                </a:cubicBezTo>
                <a:lnTo>
                  <a:pt x="967740" y="419373"/>
                </a:lnTo>
                <a:lnTo>
                  <a:pt x="990600" y="404133"/>
                </a:lnTo>
                <a:cubicBezTo>
                  <a:pt x="1024684" y="353008"/>
                  <a:pt x="984533" y="403098"/>
                  <a:pt x="1028700" y="373653"/>
                </a:cubicBezTo>
                <a:cubicBezTo>
                  <a:pt x="1037666" y="367675"/>
                  <a:pt x="1043281" y="357692"/>
                  <a:pt x="1051560" y="350793"/>
                </a:cubicBezTo>
                <a:cubicBezTo>
                  <a:pt x="1115213" y="297749"/>
                  <a:pt x="1030494" y="379479"/>
                  <a:pt x="1097280" y="312693"/>
                </a:cubicBezTo>
                <a:cubicBezTo>
                  <a:pt x="1114463" y="261144"/>
                  <a:pt x="1091770" y="323713"/>
                  <a:pt x="1127760" y="251733"/>
                </a:cubicBezTo>
                <a:cubicBezTo>
                  <a:pt x="1131352" y="244549"/>
                  <a:pt x="1131479" y="235894"/>
                  <a:pt x="1135380" y="228873"/>
                </a:cubicBezTo>
                <a:cubicBezTo>
                  <a:pt x="1158166" y="187858"/>
                  <a:pt x="1160952" y="188061"/>
                  <a:pt x="1188720" y="160293"/>
                </a:cubicBezTo>
                <a:cubicBezTo>
                  <a:pt x="1191260" y="152673"/>
                  <a:pt x="1190660" y="143113"/>
                  <a:pt x="1196340" y="137433"/>
                </a:cubicBezTo>
                <a:cubicBezTo>
                  <a:pt x="1202020" y="131753"/>
                  <a:pt x="1212179" y="133714"/>
                  <a:pt x="1219200" y="129813"/>
                </a:cubicBezTo>
                <a:cubicBezTo>
                  <a:pt x="1235211" y="120918"/>
                  <a:pt x="1249680" y="109493"/>
                  <a:pt x="1264920" y="99333"/>
                </a:cubicBezTo>
                <a:lnTo>
                  <a:pt x="1287780" y="84093"/>
                </a:lnTo>
                <a:cubicBezTo>
                  <a:pt x="1301683" y="63238"/>
                  <a:pt x="1301817" y="56688"/>
                  <a:pt x="1325880" y="45993"/>
                </a:cubicBezTo>
                <a:cubicBezTo>
                  <a:pt x="1340560" y="39469"/>
                  <a:pt x="1356360" y="35833"/>
                  <a:pt x="1371600" y="30753"/>
                </a:cubicBezTo>
                <a:cubicBezTo>
                  <a:pt x="1379220" y="28213"/>
                  <a:pt x="1387777" y="27588"/>
                  <a:pt x="1394460" y="23133"/>
                </a:cubicBezTo>
                <a:cubicBezTo>
                  <a:pt x="1416809" y="8234"/>
                  <a:pt x="1414941" y="6583"/>
                  <a:pt x="1440180" y="273"/>
                </a:cubicBezTo>
                <a:cubicBezTo>
                  <a:pt x="1442644" y="-343"/>
                  <a:pt x="1445260" y="273"/>
                  <a:pt x="1447800" y="273"/>
                </a:cubicBezTo>
              </a:path>
            </a:pathLst>
          </a:custGeom>
          <a:noFill/>
          <a:ln w="19050">
            <a:solidFill>
              <a:schemeClr val="bg2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4141984" y="4465899"/>
            <a:ext cx="6391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endParaRPr lang="en-GB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922571" y="4054923"/>
            <a:ext cx="6768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roma</a:t>
            </a:r>
            <a:endParaRPr lang="en-GB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0" y="113560"/>
            <a:ext cx="19046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s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Picture 3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4951" y="5794558"/>
            <a:ext cx="2086284" cy="2064678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203200" y="552450"/>
            <a:ext cx="21255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1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03200" y="5168900"/>
            <a:ext cx="21226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</a:t>
            </a:r>
            <a:r>
              <a:rPr lang="de-DE" dirty="0"/>
              <a:t>2</a:t>
            </a:r>
            <a:endParaRPr lang="en-GB" dirty="0"/>
          </a:p>
        </p:txBody>
      </p:sp>
      <p:pic>
        <p:nvPicPr>
          <p:cNvPr id="52" name="Picture 51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2"/>
          <a:stretch/>
        </p:blipFill>
        <p:spPr>
          <a:xfrm>
            <a:off x="2959909" y="5794558"/>
            <a:ext cx="3526896" cy="2896139"/>
          </a:xfrm>
          <a:prstGeom prst="rect">
            <a:avLst/>
          </a:prstGeom>
        </p:spPr>
      </p:pic>
      <p:sp>
        <p:nvSpPr>
          <p:cNvPr id="53" name="TextBox 52"/>
          <p:cNvSpPr txBox="1"/>
          <p:nvPr/>
        </p:nvSpPr>
        <p:spPr>
          <a:xfrm>
            <a:off x="323706" y="815312"/>
            <a:ext cx="2945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336272" y="3374034"/>
            <a:ext cx="2945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327781" y="5573872"/>
            <a:ext cx="2945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2894318" y="5517559"/>
            <a:ext cx="2945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61920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0</Words>
  <Application>Microsoft Macintosh PowerPoint</Application>
  <PresentationFormat>A4-Papier (210 x 297 mm)</PresentationFormat>
  <Paragraphs>1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Präsentation</vt:lpstr>
    </vt:vector>
  </TitlesOfParts>
  <Company>DKFZ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uch, Saskia</dc:creator>
  <cp:lastModifiedBy>Peter Angel</cp:lastModifiedBy>
  <cp:revision>224</cp:revision>
  <cp:lastPrinted>2024-01-12T09:55:11Z</cp:lastPrinted>
  <dcterms:created xsi:type="dcterms:W3CDTF">2023-06-21T13:26:00Z</dcterms:created>
  <dcterms:modified xsi:type="dcterms:W3CDTF">2024-11-27T13:25:59Z</dcterms:modified>
</cp:coreProperties>
</file>